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Aptos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ptos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271600" y="1142640"/>
            <a:ext cx="2314800" cy="3086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ptos Display"/>
              </a:rPr>
              <a:t>Click to move the slide</a:t>
            </a:r>
            <a:endParaRPr b="0" lang="en-US" sz="33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ptos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Aptos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29E72A03-CD37-43E6-A5C4-97D5496D0F75}" type="slidenum">
              <a:rPr b="0" lang="en-US" sz="1200" spc="-1" strike="noStrike">
                <a:solidFill>
                  <a:srgbClr val="000000"/>
                </a:solidFill>
                <a:latin typeface="Aptos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ptos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PlaceHolder 1"/>
          <p:cNvSpPr>
            <a:spLocks noGrp="1"/>
          </p:cNvSpPr>
          <p:nvPr>
            <p:ph type="sldImg"/>
          </p:nvPr>
        </p:nvSpPr>
        <p:spPr>
          <a:xfrm>
            <a:off x="2271600" y="1143000"/>
            <a:ext cx="2314800" cy="3086280"/>
          </a:xfrm>
          <a:prstGeom prst="rect">
            <a:avLst/>
          </a:prstGeom>
          <a:ln w="0">
            <a:noFill/>
          </a:ln>
        </p:spPr>
      </p:sp>
      <p:sp>
        <p:nvSpPr>
          <p:cNvPr id="53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ptos"/>
              </a:rPr>
              <a:t>SUPPLEMENTAL TABLE 2</a:t>
            </a:r>
            <a:endParaRPr b="0" lang="en-US" sz="12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54" name="Slide Number Placeholder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5C1753C-0C85-45DA-9A95-136B5F92F046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ptos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sldImg"/>
          </p:nvPr>
        </p:nvSpPr>
        <p:spPr>
          <a:xfrm>
            <a:off x="2271600" y="1143000"/>
            <a:ext cx="2314800" cy="3086280"/>
          </a:xfrm>
          <a:prstGeom prst="rect">
            <a:avLst/>
          </a:prstGeom>
          <a:ln w="0">
            <a:noFill/>
          </a:ln>
        </p:spPr>
      </p:sp>
      <p:sp>
        <p:nvSpPr>
          <p:cNvPr id="56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ptos"/>
              </a:rPr>
              <a:t>SUPPLEMENTAL TABLE 3 </a:t>
            </a:r>
            <a:endParaRPr b="0" lang="en-US" sz="12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57" name="Slide Number Placeholder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503ADC0-FD1C-47EE-8D0D-3C14F4B37C2F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ptos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DB0EA1-8F17-4676-90BE-9765FD6CE4F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3122F2-EB5D-46EE-99A8-7CA4CDA6C75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F2523E-9206-4E7D-81AF-6FC43B16B0E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717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715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60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717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715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DF6671-E6B9-42AA-9409-06E88C428FD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1C39A9-F04C-4DB3-8A96-E2F01E018AF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6A11E9-6002-47EA-AF99-1E7E4A3C35E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6951F3-2F9D-4004-A0F7-6D30A6B9532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961C1F-6338-471A-88AE-73DFFA478FA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1600" y="487440"/>
            <a:ext cx="5914800" cy="8191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D989C9-170E-4541-AAA6-A4A5F101DA7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E26723-E558-4035-BC38-3C4F99BA0DC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77027E-4819-4C64-9061-C5CC623B78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88E3E6-BC12-4C03-8F30-3DFC7417B44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ptos Display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ptos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Aptos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ptos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Aptos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ptos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Aptos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ptos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Aptos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ptos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Aptos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ptos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Aptos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ptos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160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900" spc="-1" strike="noStrike">
                <a:solidFill>
                  <a:srgbClr val="767676"/>
                </a:solidFill>
                <a:latin typeface="Aptos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767676"/>
                </a:solidFill>
                <a:latin typeface="Aptos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71600" y="8475480"/>
            <a:ext cx="23148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84344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900" spc="-1" strike="noStrike">
                <a:solidFill>
                  <a:srgbClr val="767676"/>
                </a:solidFill>
                <a:latin typeface="Aptos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ADACB273-383C-442D-9288-3D9F13E63AC3}" type="slidenum">
              <a:rPr b="0" lang="en-US" sz="900" spc="-1" strike="noStrike">
                <a:solidFill>
                  <a:srgbClr val="767676"/>
                </a:solidFill>
                <a:latin typeface="Aptos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Aptos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"/>
          <p:cNvGraphicFramePr/>
          <p:nvPr/>
        </p:nvGraphicFramePr>
        <p:xfrm>
          <a:off x="225360" y="320760"/>
          <a:ext cx="4176720" cy="4687920"/>
        </p:xfrm>
        <a:graphic>
          <a:graphicData uri="http://schemas.openxmlformats.org/drawingml/2006/table">
            <a:tbl>
              <a:tblPr/>
              <a:tblGrid>
                <a:gridCol w="736560"/>
                <a:gridCol w="738360"/>
                <a:gridCol w="738000"/>
                <a:gridCol w="738360"/>
                <a:gridCol w="736560"/>
                <a:gridCol w="488880"/>
              </a:tblGrid>
              <a:tr h="23004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en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C_Met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_Met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C_Primary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_Primary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vg_F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40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LRA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.1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61E-0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3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08E-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2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160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INC019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2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03E-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1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16E-2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2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04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008571.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7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18E-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.00E-1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9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40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SPO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5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.10E-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8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92E-1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7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160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LP1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9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.34E-0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11E-21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5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04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CN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5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43E-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79E-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0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04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PIFB5P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63E-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6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.75E-1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8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196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E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18E-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0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36E-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5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04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IBCD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7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.06E-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4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26E-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5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160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244502.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5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29E-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10E-1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5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04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244502.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5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49E-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3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19E-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4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40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TPR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2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50E-0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39E-0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160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013643.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8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09E-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3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.92E-1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04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007255.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6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58E-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3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22E-1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40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390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8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17E-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1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90E-1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9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160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ABR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20E-0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2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42E-2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8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04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068987.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4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28E-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1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34E-1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8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40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L022324.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81E-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62E-2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160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L590428.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9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01E-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1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83E-1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04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005996.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9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24E-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0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34E-2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160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RYG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39E-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14E-1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40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DAMTS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9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22E-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36E-1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4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9" name="TextBox 4"/>
          <p:cNvSpPr/>
          <p:nvPr/>
        </p:nvSpPr>
        <p:spPr>
          <a:xfrm>
            <a:off x="147600" y="68400"/>
            <a:ext cx="4503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Segoe UI"/>
                <a:ea typeface="Segoe UI"/>
              </a:rPr>
              <a:t>Common Genes Upregulated in </a:t>
            </a:r>
            <a:r>
              <a:rPr b="0" i="1" lang="en-US" sz="1000" spc="-1" strike="noStrike">
                <a:solidFill>
                  <a:srgbClr val="000000"/>
                </a:solidFill>
                <a:latin typeface="Segoe UI"/>
                <a:ea typeface="Segoe UI"/>
              </a:rPr>
              <a:t>GLP-1R-high</a:t>
            </a:r>
            <a:r>
              <a:rPr b="0" lang="en-US" sz="1000" spc="-1" strike="noStrike">
                <a:solidFill>
                  <a:srgbClr val="000000"/>
                </a:solidFill>
                <a:latin typeface="Segoe UI"/>
                <a:ea typeface="Segoe UI"/>
              </a:rPr>
              <a:t> Primary and Met Tissue</a:t>
            </a:r>
            <a:endParaRPr b="0" lang="en-US" sz="1000" spc="-1" strike="noStrike">
              <a:solidFill>
                <a:srgbClr val="000000"/>
              </a:solidFill>
              <a:latin typeface="Aptos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0" name=""/>
          <p:cNvGraphicFramePr/>
          <p:nvPr/>
        </p:nvGraphicFramePr>
        <p:xfrm>
          <a:off x="193680" y="401760"/>
          <a:ext cx="4998960" cy="6889680"/>
        </p:xfrm>
        <a:graphic>
          <a:graphicData uri="http://schemas.openxmlformats.org/drawingml/2006/table">
            <a:tbl>
              <a:tblPr/>
              <a:tblGrid>
                <a:gridCol w="833400"/>
                <a:gridCol w="833400"/>
                <a:gridCol w="833400"/>
                <a:gridCol w="833400"/>
                <a:gridCol w="831960"/>
                <a:gridCol w="833400"/>
              </a:tblGrid>
              <a:tr h="20304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en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C_Met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_Met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C_Primary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_Primary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vg_F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160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L3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5.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0E-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2.7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93E-1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4.2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40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OL11A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4.5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48E-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2.5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17E-1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3.5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04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GLV6-5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5.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76E-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.5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47E-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3.4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160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GKV1D-1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5.8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.94E-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.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22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3.4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40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GLV2-2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5.5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23E-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.2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30E-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3.4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160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GHV3-6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5.2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.72E-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.4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36E-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3.3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04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RTM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3.9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94E-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2.6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0E-2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3.2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04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GLV1-4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.21E-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.4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25E-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3.2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160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GHV3-3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5.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85E-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.1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17E-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3.1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40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MU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5.0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18E-1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.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83E-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3.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04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RRC1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4.1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22E-0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.9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66E-1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3.0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160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ST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3.8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93E-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2.0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.11E-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2.9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40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GHV4-3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4.7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91E-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.1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59E-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2.9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04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GLV2-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4.5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.46E-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.2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.06E-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2.9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160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GHV3-4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4.6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03E-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.1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67E-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2.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40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GHGP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4.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.16E-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.4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.85E-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2.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160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GKV2-3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4.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.65E-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.0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77E-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2.8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04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GKV3-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4.3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64E-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.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25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2.7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40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L391650.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3.6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31E-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.7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.13E-2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2.7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160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GHG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4.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38E-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.1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83E-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2.6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04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GLV3-2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4.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87E-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.2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12E-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2.6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40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GLC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4.0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95E-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.1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34E-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2.6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160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PON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3.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56E-0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.2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1E-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2.5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04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GHG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3.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41E-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.2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13E-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2.5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40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KCND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3.5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94E-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.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5E-0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2.3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160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XCL1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3.1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09E-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.3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45E-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2.2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04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TP10B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3.2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73E-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.0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.98E-0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2.1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160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LCO4C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2.9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67E-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.2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0E-1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2.1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04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ST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2.8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16E-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.0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.21E-0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.9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40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IBI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2.6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24E-0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.2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49E-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.9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160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CN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2.2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.19E-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.0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5E-0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.6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04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LD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2.1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3E-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.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00E-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.6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400">
                <a:tc>
                  <a:txBody>
                    <a:bodyPr lIns="8640" rIns="8640" tIns="8640" bIns="414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URAP1L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.9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.06E-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.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14E-1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4140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.5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ptos"/>
                      </a:endParaRPr>
                    </a:p>
                  </a:txBody>
                  <a:tcPr anchor="b" marL="8640" marR="86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51" name="TextBox 3"/>
          <p:cNvSpPr/>
          <p:nvPr/>
        </p:nvSpPr>
        <p:spPr>
          <a:xfrm>
            <a:off x="138240" y="149400"/>
            <a:ext cx="4503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830160"/>
                <a:tab algn="l" pos="1660680"/>
                <a:tab algn="l" pos="2490840"/>
                <a:tab algn="l" pos="3321000"/>
                <a:tab algn="l" pos="4151160"/>
                <a:tab algn="l" pos="4981680"/>
                <a:tab algn="l" pos="5811840"/>
                <a:tab algn="l" pos="6642000"/>
                <a:tab algn="l" pos="7472520"/>
                <a:tab algn="l" pos="8302680"/>
                <a:tab algn="l" pos="9132840"/>
                <a:tab algn="l" pos="9963000"/>
                <a:tab algn="l" pos="107935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Segoe UI"/>
                <a:ea typeface="Segoe UI"/>
              </a:rPr>
              <a:t>Common Genes Upregulated in </a:t>
            </a:r>
            <a:r>
              <a:rPr b="0" i="1" lang="en-US" sz="1000" spc="-1" strike="noStrike">
                <a:solidFill>
                  <a:srgbClr val="000000"/>
                </a:solidFill>
                <a:latin typeface="Segoe UI"/>
                <a:ea typeface="Segoe UI"/>
              </a:rPr>
              <a:t>GLP-1R-low</a:t>
            </a:r>
            <a:r>
              <a:rPr b="0" lang="en-US" sz="1000" spc="-1" strike="noStrike">
                <a:solidFill>
                  <a:srgbClr val="000000"/>
                </a:solidFill>
                <a:latin typeface="Segoe UI"/>
                <a:ea typeface="Segoe UI"/>
              </a:rPr>
              <a:t> Primary and Met Tissue</a:t>
            </a:r>
            <a:endParaRPr b="0" lang="en-US" sz="1000" spc="-1" strike="noStrike">
              <a:solidFill>
                <a:srgbClr val="000000"/>
              </a:solidFill>
              <a:latin typeface="Aptos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6-05-20T18:54:26Z</dcterms:created>
  <dc:creator>Kennedy, Sophia</dc:creator>
  <dc:description/>
  <dc:language>en-US</dc:language>
  <cp:lastModifiedBy>Kennedy, Sophia</cp:lastModifiedBy>
  <dcterms:modified xsi:type="dcterms:W3CDTF">2026-05-20T19:08:47Z</dcterms:modified>
  <cp:revision>1</cp:revision>
  <dc:subject/>
  <dc:title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0F6930282A870489CAF4755AF4D9B9E</vt:lpwstr>
  </property>
  <property fmtid="{D5CDD505-2E9C-101B-9397-08002B2CF9AE}" pid="3" name="TaxCatchAll">
    <vt:lpwstr/>
  </property>
  <property fmtid="{D5CDD505-2E9C-101B-9397-08002B2CF9AE}" pid="4" name="lcf76f155ced4ddcb4097134ff3c332f">
    <vt:lpwstr/>
  </property>
</Properties>
</file>